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1891CE-7587-4996-AAA9-4A0637E867A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AD18CF-8167-47AC-972A-42CDC86C57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D22BEE-65CF-4D71-A07E-0A27A1615B5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03080D-75A7-44ED-A469-A3ED463DF62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BAC35C-E8E4-410A-A282-C9F2FC1AF7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84D131-ED93-4B46-AC37-8C34A0295D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665E30-A6FE-4CF5-BBEB-A96F5B3E3C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8FFE13-DF76-499C-B6A9-6EB3E7E04C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49A270-8BAA-40BA-9907-4E16D889AA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596A41-5D3C-4C60-8F92-C6420A5DEC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377529-08F2-46D2-B80F-31A05B8012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906C98-FF21-4496-ACE6-307F1FEC5D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D3113D-58A0-4E7E-A247-FA66E2384E7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subTitle"/>
          </p:nvPr>
        </p:nvSpPr>
        <p:spPr>
          <a:xfrm>
            <a:off x="533160" y="5866920"/>
            <a:ext cx="7848360" cy="8384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algn="ctr">
              <a:lnSpc>
                <a:spcPct val="100000"/>
              </a:lnSpc>
              <a:spcBef>
                <a:spcPts val="4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2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qRT-PCR assisted validation of pathogen induced differential fold induction of microarray data</a:t>
            </a:r>
            <a:r>
              <a:rPr b="0" lang="en-US" sz="1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4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3" descr="supporting  figure 1.tif"/>
          <p:cNvPicPr/>
          <p:nvPr/>
        </p:nvPicPr>
        <p:blipFill>
          <a:blip r:embed="rId1"/>
          <a:stretch/>
        </p:blipFill>
        <p:spPr>
          <a:xfrm>
            <a:off x="380880" y="304920"/>
            <a:ext cx="7925040" cy="5395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Prof. Sampa Das</dc:creator>
  <dc:description/>
  <dc:language>en-US</dc:language>
  <cp:lastModifiedBy>Prof. Sampa Das</cp:lastModifiedBy>
  <dcterms:modified xsi:type="dcterms:W3CDTF">2011-12-19T09:36:21Z</dcterms:modified>
  <cp:revision>3</cp:revision>
  <dc:subject/>
  <dc:title>Slide 1</dc:title>
</cp:coreProperties>
</file>